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6" autoAdjust="0"/>
    <p:restoredTop sz="94660"/>
  </p:normalViewPr>
  <p:slideViewPr>
    <p:cSldViewPr snapToGrid="0">
      <p:cViewPr varScale="1">
        <p:scale>
          <a:sx n="76" d="100"/>
          <a:sy n="76" d="100"/>
        </p:scale>
        <p:origin x="126" y="9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6BE7BF-338E-4863-B788-7E21444860BB}" type="datetimeFigureOut">
              <a:rPr lang="de-DE" smtClean="0"/>
              <a:t>05.04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A6CE2-E75E-42E4-BE8B-A953B9E74A6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957918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6BE7BF-338E-4863-B788-7E21444860BB}" type="datetimeFigureOut">
              <a:rPr lang="de-DE" smtClean="0"/>
              <a:t>05.04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A6CE2-E75E-42E4-BE8B-A953B9E74A6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600487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6BE7BF-338E-4863-B788-7E21444860BB}" type="datetimeFigureOut">
              <a:rPr lang="de-DE" smtClean="0"/>
              <a:t>05.04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A6CE2-E75E-42E4-BE8B-A953B9E74A6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082570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6BE7BF-338E-4863-B788-7E21444860BB}" type="datetimeFigureOut">
              <a:rPr lang="de-DE" smtClean="0"/>
              <a:t>05.04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A6CE2-E75E-42E4-BE8B-A953B9E74A6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323748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6BE7BF-338E-4863-B788-7E21444860BB}" type="datetimeFigureOut">
              <a:rPr lang="de-DE" smtClean="0"/>
              <a:t>05.04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A6CE2-E75E-42E4-BE8B-A953B9E74A6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151602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6BE7BF-338E-4863-B788-7E21444860BB}" type="datetimeFigureOut">
              <a:rPr lang="de-DE" smtClean="0"/>
              <a:t>05.04.20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A6CE2-E75E-42E4-BE8B-A953B9E74A6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027872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6BE7BF-338E-4863-B788-7E21444860BB}" type="datetimeFigureOut">
              <a:rPr lang="de-DE" smtClean="0"/>
              <a:t>05.04.2018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A6CE2-E75E-42E4-BE8B-A953B9E74A6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324646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6BE7BF-338E-4863-B788-7E21444860BB}" type="datetimeFigureOut">
              <a:rPr lang="de-DE" smtClean="0"/>
              <a:t>05.04.2018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A6CE2-E75E-42E4-BE8B-A953B9E74A6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951243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6BE7BF-338E-4863-B788-7E21444860BB}" type="datetimeFigureOut">
              <a:rPr lang="de-DE" smtClean="0"/>
              <a:t>05.04.2018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A6CE2-E75E-42E4-BE8B-A953B9E74A6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738518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6BE7BF-338E-4863-B788-7E21444860BB}" type="datetimeFigureOut">
              <a:rPr lang="de-DE" smtClean="0"/>
              <a:t>05.04.20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A6CE2-E75E-42E4-BE8B-A953B9E74A6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340432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6BE7BF-338E-4863-B788-7E21444860BB}" type="datetimeFigureOut">
              <a:rPr lang="de-DE" smtClean="0"/>
              <a:t>05.04.20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A6CE2-E75E-42E4-BE8B-A953B9E74A6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653542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6BE7BF-338E-4863-B788-7E21444860BB}" type="datetimeFigureOut">
              <a:rPr lang="de-DE" smtClean="0"/>
              <a:t>05.04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7A6CE2-E75E-42E4-BE8B-A953B9E74A6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769006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el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44464602"/>
              </p:ext>
            </p:extLst>
          </p:nvPr>
        </p:nvGraphicFramePr>
        <p:xfrm>
          <a:off x="3280410" y="91427"/>
          <a:ext cx="5612130" cy="6652278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561213"/>
                <a:gridCol w="561213"/>
                <a:gridCol w="561213"/>
                <a:gridCol w="561213"/>
                <a:gridCol w="561213"/>
                <a:gridCol w="561213"/>
                <a:gridCol w="561213"/>
                <a:gridCol w="561213"/>
                <a:gridCol w="561213"/>
                <a:gridCol w="561213"/>
              </a:tblGrid>
              <a:tr h="220110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 dirty="0" err="1">
                          <a:effectLst/>
                        </a:rPr>
                        <a:t>Bending</a:t>
                      </a:r>
                      <a:r>
                        <a:rPr lang="de-DE" sz="400" u="none" strike="noStrike" dirty="0">
                          <a:effectLst/>
                        </a:rPr>
                        <a:t>-</a:t>
                      </a:r>
                      <a:br>
                        <a:rPr lang="de-DE" sz="400" u="none" strike="noStrike" dirty="0">
                          <a:effectLst/>
                        </a:rPr>
                      </a:br>
                      <a:r>
                        <a:rPr lang="de-DE" sz="400" u="none" strike="noStrike" dirty="0" err="1">
                          <a:effectLst/>
                        </a:rPr>
                        <a:t>setting</a:t>
                      </a:r>
                      <a:endParaRPr lang="de-DE" sz="4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Rat Nr.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Weight</a:t>
                      </a:r>
                      <a:br>
                        <a:rPr lang="de-DE" sz="400" u="none" strike="noStrike">
                          <a:effectLst/>
                        </a:rPr>
                      </a:br>
                      <a:r>
                        <a:rPr lang="de-DE" sz="400" u="none" strike="noStrike">
                          <a:effectLst/>
                        </a:rPr>
                        <a:t>(g)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Side</a:t>
                      </a:r>
                      <a:br>
                        <a:rPr lang="de-DE" sz="400" u="none" strike="noStrike">
                          <a:effectLst/>
                        </a:rPr>
                      </a:br>
                      <a:r>
                        <a:rPr lang="de-DE" sz="400" u="none" strike="noStrike">
                          <a:effectLst/>
                        </a:rPr>
                        <a:t>(l/r)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Subgroub </a:t>
                      </a:r>
                      <a:br>
                        <a:rPr lang="de-DE" sz="400" u="none" strike="noStrike">
                          <a:effectLst/>
                        </a:rPr>
                      </a:br>
                      <a:r>
                        <a:rPr lang="de-DE" sz="400" u="none" strike="noStrike">
                          <a:effectLst/>
                        </a:rPr>
                        <a:t>(h/l)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Lenght </a:t>
                      </a:r>
                      <a:br>
                        <a:rPr lang="de-DE" sz="400" u="none" strike="noStrike">
                          <a:effectLst/>
                        </a:rPr>
                      </a:br>
                      <a:r>
                        <a:rPr lang="de-DE" sz="400" u="none" strike="noStrike">
                          <a:effectLst/>
                        </a:rPr>
                        <a:t>(mm)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Failure Load </a:t>
                      </a:r>
                      <a:br>
                        <a:rPr lang="de-DE" sz="400" u="none" strike="noStrike">
                          <a:effectLst/>
                        </a:rPr>
                      </a:br>
                      <a:r>
                        <a:rPr lang="de-DE" sz="400" u="none" strike="noStrike">
                          <a:effectLst/>
                        </a:rPr>
                        <a:t>(N)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Stiffness </a:t>
                      </a:r>
                      <a:br>
                        <a:rPr lang="de-DE" sz="400" u="none" strike="noStrike">
                          <a:effectLst/>
                        </a:rPr>
                      </a:br>
                      <a:r>
                        <a:rPr lang="de-DE" sz="400" u="none" strike="noStrike">
                          <a:effectLst/>
                        </a:rPr>
                        <a:t>(N/mm)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BMD DXA </a:t>
                      </a:r>
                      <a:br>
                        <a:rPr lang="de-DE" sz="400" u="none" strike="noStrike">
                          <a:effectLst/>
                        </a:rPr>
                      </a:br>
                      <a:r>
                        <a:rPr lang="de-DE" sz="400" u="none" strike="noStrike">
                          <a:effectLst/>
                        </a:rPr>
                        <a:t>(HAg/cm³)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BMC DXA </a:t>
                      </a:r>
                      <a:br>
                        <a:rPr lang="de-DE" sz="400" u="none" strike="noStrike">
                          <a:effectLst/>
                        </a:rPr>
                      </a:br>
                      <a:r>
                        <a:rPr lang="de-DE" sz="400" u="none" strike="noStrike">
                          <a:effectLst/>
                        </a:rPr>
                        <a:t>(mg)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</a:tr>
              <a:tr h="110056">
                <a:tc rowSpan="40"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Individual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vert="vert270" anchor="ctr"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1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342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l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l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35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126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268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0,1763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0,3252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</a:tr>
              <a:tr h="110056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r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l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35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116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222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0,1768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0,3271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</a:tr>
              <a:tr h="103942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2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354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l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l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35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128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233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0,1782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0,3363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</a:tr>
              <a:tr h="110056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r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l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35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130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292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0,1787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0,3331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</a:tr>
              <a:tr h="103942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3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350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l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l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34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137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185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0,1808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0,3223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</a:tr>
              <a:tr h="110056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r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l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34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144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281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0,1799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0,3178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</a:tr>
              <a:tr h="103942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4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332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l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l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35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132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210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0,1705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0,3105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</a:tr>
              <a:tr h="110056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r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l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35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130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267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0,1727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0,3227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</a:tr>
              <a:tr h="103942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5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240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l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l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35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162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377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0,2213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0,4152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</a:tr>
              <a:tr h="110056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r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l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35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161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395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0,2219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0,4149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</a:tr>
              <a:tr h="103942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6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333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l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l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34,5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133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241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0,1708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0,3223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</a:tr>
              <a:tr h="110056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r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l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34,5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141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217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0,1781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0,3382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</a:tr>
              <a:tr h="103942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7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343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l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l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35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128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265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0,1755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0,3284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</a:tr>
              <a:tr h="110056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r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l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35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124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243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0,1755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0,3277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</a:tr>
              <a:tr h="103942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8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340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l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l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37,5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130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309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0,2345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0,4735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</a:tr>
              <a:tr h="110056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r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l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37,5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142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338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0,229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0,4492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</a:tr>
              <a:tr h="103942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9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558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l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h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44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232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383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0,2703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0,7584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</a:tr>
              <a:tr h="110056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r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h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42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237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422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0,2714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0,7318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</a:tr>
              <a:tr h="103942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10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654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l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h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45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233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359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0,2538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0,7351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</a:tr>
              <a:tr h="110056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r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h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44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205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332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0,2512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0,7264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</a:tr>
              <a:tr h="103942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11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666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l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h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43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231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330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0,2669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0,788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</a:tr>
              <a:tr h="110056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r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h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43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240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405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0,2591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0,7934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</a:tr>
              <a:tr h="103942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12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590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l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h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41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216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317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0,2608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0,7395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</a:tr>
              <a:tr h="110056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r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h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43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204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353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0,2581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0,7178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</a:tr>
              <a:tr h="103942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13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641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l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h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43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211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363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0,284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0,8362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</a:tr>
              <a:tr h="110056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r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h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43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234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318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0,2801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0,8277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</a:tr>
              <a:tr h="103942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14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582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l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h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44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226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321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0,2857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0,8377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</a:tr>
              <a:tr h="110056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r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h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41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241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381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0,2681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0,6936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</a:tr>
              <a:tr h="103942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15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690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l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h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46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199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351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0,2595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0,7806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</a:tr>
              <a:tr h="110056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r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h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45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211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331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0,2522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0,7734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</a:tr>
              <a:tr h="103942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16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 dirty="0">
                          <a:effectLst/>
                        </a:rPr>
                        <a:t>656</a:t>
                      </a:r>
                      <a:endParaRPr lang="de-DE" sz="4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l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h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45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230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373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0,274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0,841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</a:tr>
              <a:tr h="110056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r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h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42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251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426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0,2758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0,8563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</a:tr>
              <a:tr h="103942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17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386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l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l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38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173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358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0,2579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0,5893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</a:tr>
              <a:tr h="110056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r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l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38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179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398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0,2515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0,5854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</a:tr>
              <a:tr h="103942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18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740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l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h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41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198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357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0,2579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0,7235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</a:tr>
              <a:tr h="110056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r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h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41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179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324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0,2531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0,694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</a:tr>
              <a:tr h="103942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19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372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l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l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37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127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277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0,2211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0,4805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</a:tr>
              <a:tr h="110056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r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l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37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137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291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0,2276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0,4625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</a:tr>
              <a:tr h="103942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20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354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l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l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34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129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259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0,1846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0,3511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</a:tr>
              <a:tr h="110056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r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l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34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129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252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0,1857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0,3537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</a:tr>
              <a:tr h="110056">
                <a:tc rowSpan="20"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fixed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vert="vert270" anchor="ctr"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21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632,5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l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h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43,5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180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388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n.a.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n.a.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</a:tr>
              <a:tr h="110056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r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h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45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185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425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n.a.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n.a.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</a:tr>
              <a:tr h="103942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22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585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l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h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44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179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437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n.a.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n.a.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</a:tr>
              <a:tr h="110056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r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h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41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184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471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n.a.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n.a.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</a:tr>
              <a:tr h="103942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23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613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l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h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42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205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481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n.a.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n.a.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</a:tr>
              <a:tr h="110056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r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h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42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143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381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n.a.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n.a.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</a:tr>
              <a:tr h="103942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24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620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l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h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45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202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556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n.a.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n.a.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</a:tr>
              <a:tr h="110056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r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h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42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199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482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n.a.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n.a.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</a:tr>
              <a:tr h="103942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25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666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l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h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44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196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455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n.a.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n.a.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</a:tr>
              <a:tr h="110056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r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h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42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286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807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n.a.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n.a.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</a:tr>
              <a:tr h="103942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26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640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l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h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42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211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503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n.a.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n.a.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</a:tr>
              <a:tr h="110056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r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h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43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213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521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n.a.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n.a.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</a:tr>
              <a:tr h="103942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27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679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l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h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43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235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643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n.a.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n.a.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</a:tr>
              <a:tr h="110056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r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h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43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233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440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n.a.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n.a.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</a:tr>
              <a:tr h="103942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28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654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l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h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44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193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546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n.a.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n.a.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</a:tr>
              <a:tr h="110056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r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h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42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187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430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n.a.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n.a.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</a:tr>
              <a:tr h="103942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29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646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l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h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41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247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619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n.a.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n.a.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</a:tr>
              <a:tr h="110056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r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h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43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224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397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n.a.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n.a.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</a:tr>
              <a:tr h="103942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30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610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l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h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42,5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187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407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n.a.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n.a.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</a:tr>
              <a:tr h="110056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r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h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44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218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580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>
                          <a:effectLst/>
                        </a:rPr>
                        <a:t>n.a.</a:t>
                      </a:r>
                      <a:endParaRPr lang="de-DE" sz="4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400" u="none" strike="noStrike" dirty="0" err="1">
                          <a:effectLst/>
                        </a:rPr>
                        <a:t>n.a</a:t>
                      </a:r>
                      <a:r>
                        <a:rPr lang="de-DE" sz="400" u="none" strike="noStrike" dirty="0">
                          <a:effectLst/>
                        </a:rPr>
                        <a:t>.</a:t>
                      </a:r>
                      <a:endParaRPr lang="de-DE" sz="4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999" marR="3999" marT="3999" marB="0" anchor="ctr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2262858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37</Words>
  <Application>Microsoft Office PowerPoint</Application>
  <PresentationFormat>Breitbild</PresentationFormat>
  <Paragraphs>492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-Prä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admin</dc:creator>
  <cp:lastModifiedBy>admin</cp:lastModifiedBy>
  <cp:revision>47</cp:revision>
  <dcterms:created xsi:type="dcterms:W3CDTF">2017-03-10T11:07:33Z</dcterms:created>
  <dcterms:modified xsi:type="dcterms:W3CDTF">2018-04-05T20:04:58Z</dcterms:modified>
</cp:coreProperties>
</file>